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43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9712" y="390571"/>
            <a:ext cx="5400600" cy="534268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79512" y="5733256"/>
            <a:ext cx="89644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6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edicted protein-protein interaction network of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EG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pecifically expressed in Group III (comparison between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SaSbSc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vs </a:t>
            </a:r>
            <a:r>
              <a:rPr lang="en-US" altLang="zh-CN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zh-CN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839334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1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wjw</cp:lastModifiedBy>
  <cp:revision>2</cp:revision>
  <dcterms:modified xsi:type="dcterms:W3CDTF">2017-10-19T07:45:39Z</dcterms:modified>
</cp:coreProperties>
</file>